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  <p:sldId id="260" r:id="rId4"/>
    <p:sldId id="261" r:id="rId5"/>
    <p:sldId id="258" r:id="rId6"/>
    <p:sldId id="259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70F448-2C5D-4B03-9E40-925F393A1AC7}" v="39" dt="2021-03-26T23:18:28.7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7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48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7570F448-2C5D-4B03-9E40-925F393A1AC7}"/>
    <pc:docChg chg="undo custSel addSld modSld">
      <pc:chgData name="Sarah Hill" userId="b774f213905f0ee8" providerId="LiveId" clId="{7570F448-2C5D-4B03-9E40-925F393A1AC7}" dt="2021-03-27T18:14:49.187" v="1303" actId="20577"/>
      <pc:docMkLst>
        <pc:docMk/>
      </pc:docMkLst>
      <pc:sldChg chg="addSp delSp modSp mod">
        <pc:chgData name="Sarah Hill" userId="b774f213905f0ee8" providerId="LiveId" clId="{7570F448-2C5D-4B03-9E40-925F393A1AC7}" dt="2021-03-25T12:21:59.588" v="1051" actId="1035"/>
        <pc:sldMkLst>
          <pc:docMk/>
          <pc:sldMk cId="2724142132" sldId="256"/>
        </pc:sldMkLst>
        <pc:spChg chg="del mod">
          <ac:chgData name="Sarah Hill" userId="b774f213905f0ee8" providerId="LiveId" clId="{7570F448-2C5D-4B03-9E40-925F393A1AC7}" dt="2021-03-25T12:15:56.671" v="711" actId="478"/>
          <ac:spMkLst>
            <pc:docMk/>
            <pc:sldMk cId="2724142132" sldId="256"/>
            <ac:spMk id="6" creationId="{F8A31554-5F51-4A15-869F-6620DC6BB688}"/>
          </ac:spMkLst>
        </pc:spChg>
        <pc:spChg chg="add del mod">
          <ac:chgData name="Sarah Hill" userId="b774f213905f0ee8" providerId="LiveId" clId="{7570F448-2C5D-4B03-9E40-925F393A1AC7}" dt="2021-03-25T12:15:58.545" v="713" actId="478"/>
          <ac:spMkLst>
            <pc:docMk/>
            <pc:sldMk cId="2724142132" sldId="256"/>
            <ac:spMk id="7" creationId="{6DEDE2D5-9E7F-40BB-81A7-27F3ACD4ADD2}"/>
          </ac:spMkLst>
        </pc:spChg>
        <pc:spChg chg="add del mod">
          <ac:chgData name="Sarah Hill" userId="b774f213905f0ee8" providerId="LiveId" clId="{7570F448-2C5D-4B03-9E40-925F393A1AC7}" dt="2021-03-25T05:11:07.332" v="434" actId="478"/>
          <ac:spMkLst>
            <pc:docMk/>
            <pc:sldMk cId="2724142132" sldId="256"/>
            <ac:spMk id="8" creationId="{425A1382-57BB-452C-8642-E837D31BAC81}"/>
          </ac:spMkLst>
        </pc:spChg>
        <pc:spChg chg="add mod">
          <ac:chgData name="Sarah Hill" userId="b774f213905f0ee8" providerId="LiveId" clId="{7570F448-2C5D-4B03-9E40-925F393A1AC7}" dt="2021-03-25T12:16:30.264" v="723" actId="14100"/>
          <ac:spMkLst>
            <pc:docMk/>
            <pc:sldMk cId="2724142132" sldId="256"/>
            <ac:spMk id="8" creationId="{A05EBF49-2D99-464A-8878-597A0BCAC094}"/>
          </ac:spMkLst>
        </pc:spChg>
        <pc:spChg chg="add mod">
          <ac:chgData name="Sarah Hill" userId="b774f213905f0ee8" providerId="LiveId" clId="{7570F448-2C5D-4B03-9E40-925F393A1AC7}" dt="2021-03-25T05:23:33.447" v="707" actId="1076"/>
          <ac:spMkLst>
            <pc:docMk/>
            <pc:sldMk cId="2724142132" sldId="256"/>
            <ac:spMk id="9" creationId="{97EDDC58-2223-400A-B6F4-F0870F726721}"/>
          </ac:spMkLst>
        </pc:spChg>
        <pc:spChg chg="add del mod">
          <ac:chgData name="Sarah Hill" userId="b774f213905f0ee8" providerId="LiveId" clId="{7570F448-2C5D-4B03-9E40-925F393A1AC7}" dt="2021-03-25T12:21:50.862" v="980" actId="478"/>
          <ac:spMkLst>
            <pc:docMk/>
            <pc:sldMk cId="2724142132" sldId="256"/>
            <ac:spMk id="10" creationId="{A4A0274D-A1CA-44FA-B4E1-599152818BD0}"/>
          </ac:spMkLst>
        </pc:spChg>
        <pc:spChg chg="add mod">
          <ac:chgData name="Sarah Hill" userId="b774f213905f0ee8" providerId="LiveId" clId="{7570F448-2C5D-4B03-9E40-925F393A1AC7}" dt="2021-03-25T12:21:55.653" v="1014" actId="1035"/>
          <ac:spMkLst>
            <pc:docMk/>
            <pc:sldMk cId="2724142132" sldId="256"/>
            <ac:spMk id="11" creationId="{4B1EB5E5-0300-4AB2-A26D-D35E71656713}"/>
          </ac:spMkLst>
        </pc:spChg>
        <pc:spChg chg="add del mod">
          <ac:chgData name="Sarah Hill" userId="b774f213905f0ee8" providerId="LiveId" clId="{7570F448-2C5D-4B03-9E40-925F393A1AC7}" dt="2021-03-25T05:23:30.277" v="706" actId="478"/>
          <ac:spMkLst>
            <pc:docMk/>
            <pc:sldMk cId="2724142132" sldId="256"/>
            <ac:spMk id="12" creationId="{98B50D47-951A-44CE-B2A0-06E5774F9E9B}"/>
          </ac:spMkLst>
        </pc:spChg>
        <pc:spChg chg="add mod">
          <ac:chgData name="Sarah Hill" userId="b774f213905f0ee8" providerId="LiveId" clId="{7570F448-2C5D-4B03-9E40-925F393A1AC7}" dt="2021-03-25T12:21:59.588" v="1051" actId="1035"/>
          <ac:spMkLst>
            <pc:docMk/>
            <pc:sldMk cId="2724142132" sldId="256"/>
            <ac:spMk id="12" creationId="{F4E12B86-BCF5-4395-8FE6-E23A1FE910F4}"/>
          </ac:spMkLst>
        </pc:spChg>
        <pc:spChg chg="add mod">
          <ac:chgData name="Sarah Hill" userId="b774f213905f0ee8" providerId="LiveId" clId="{7570F448-2C5D-4B03-9E40-925F393A1AC7}" dt="2021-03-25T12:16:21.887" v="721" actId="1076"/>
          <ac:spMkLst>
            <pc:docMk/>
            <pc:sldMk cId="2724142132" sldId="256"/>
            <ac:spMk id="13" creationId="{9366E9FD-5C98-4173-9E36-A49670CC87C6}"/>
          </ac:spMkLst>
        </pc:spChg>
        <pc:spChg chg="add del mod">
          <ac:chgData name="Sarah Hill" userId="b774f213905f0ee8" providerId="LiveId" clId="{7570F448-2C5D-4B03-9E40-925F393A1AC7}" dt="2021-03-25T05:23:30.277" v="706" actId="478"/>
          <ac:spMkLst>
            <pc:docMk/>
            <pc:sldMk cId="2724142132" sldId="256"/>
            <ac:spMk id="13" creationId="{E4DD6B50-A649-4CA6-BF1D-F316DFE8B57B}"/>
          </ac:spMkLst>
        </pc:spChg>
        <pc:spChg chg="add del mod">
          <ac:chgData name="Sarah Hill" userId="b774f213905f0ee8" providerId="LiveId" clId="{7570F448-2C5D-4B03-9E40-925F393A1AC7}" dt="2021-03-25T05:23:30.277" v="706" actId="478"/>
          <ac:spMkLst>
            <pc:docMk/>
            <pc:sldMk cId="2724142132" sldId="256"/>
            <ac:spMk id="14" creationId="{493A07ED-762F-4BC7-A320-2E73D1332B43}"/>
          </ac:spMkLst>
        </pc:spChg>
        <pc:spChg chg="add del mod">
          <ac:chgData name="Sarah Hill" userId="b774f213905f0ee8" providerId="LiveId" clId="{7570F448-2C5D-4B03-9E40-925F393A1AC7}" dt="2021-03-25T05:23:30.277" v="706" actId="478"/>
          <ac:spMkLst>
            <pc:docMk/>
            <pc:sldMk cId="2724142132" sldId="256"/>
            <ac:spMk id="15" creationId="{747FC8AF-DE5D-4C48-85AA-756E135C1124}"/>
          </ac:spMkLst>
        </pc:spChg>
        <pc:picChg chg="mod modCrop">
          <ac:chgData name="Sarah Hill" userId="b774f213905f0ee8" providerId="LiveId" clId="{7570F448-2C5D-4B03-9E40-925F393A1AC7}" dt="2021-03-25T05:23:33.447" v="707" actId="1076"/>
          <ac:picMkLst>
            <pc:docMk/>
            <pc:sldMk cId="2724142132" sldId="256"/>
            <ac:picMk id="5" creationId="{60931D64-0642-4A8F-9391-7766EE9E4C7A}"/>
          </ac:picMkLst>
        </pc:picChg>
        <pc:picChg chg="add del mod modCrop">
          <ac:chgData name="Sarah Hill" userId="b774f213905f0ee8" providerId="LiveId" clId="{7570F448-2C5D-4B03-9E40-925F393A1AC7}" dt="2021-03-25T05:11:09.750" v="435" actId="478"/>
          <ac:picMkLst>
            <pc:docMk/>
            <pc:sldMk cId="2724142132" sldId="256"/>
            <ac:picMk id="11" creationId="{DAC26A4C-A83B-4409-8291-E682D43DB97F}"/>
          </ac:picMkLst>
        </pc:picChg>
        <pc:picChg chg="add del mod modCrop">
          <ac:chgData name="Sarah Hill" userId="b774f213905f0ee8" providerId="LiveId" clId="{7570F448-2C5D-4B03-9E40-925F393A1AC7}" dt="2021-03-25T05:22:09.784" v="603" actId="21"/>
          <ac:picMkLst>
            <pc:docMk/>
            <pc:sldMk cId="2724142132" sldId="256"/>
            <ac:picMk id="17" creationId="{78FE5DFA-8853-4ABB-9B10-754D145F46D7}"/>
          </ac:picMkLst>
        </pc:picChg>
        <pc:picChg chg="add del mod modCrop">
          <ac:chgData name="Sarah Hill" userId="b774f213905f0ee8" providerId="LiveId" clId="{7570F448-2C5D-4B03-9E40-925F393A1AC7}" dt="2021-03-25T05:22:14.844" v="606" actId="21"/>
          <ac:picMkLst>
            <pc:docMk/>
            <pc:sldMk cId="2724142132" sldId="256"/>
            <ac:picMk id="19" creationId="{057577CB-43D5-4021-9D2B-83FCB7FBACEA}"/>
          </ac:picMkLst>
        </pc:picChg>
      </pc:sldChg>
      <pc:sldChg chg="addSp modSp mod">
        <pc:chgData name="Sarah Hill" userId="b774f213905f0ee8" providerId="LiveId" clId="{7570F448-2C5D-4B03-9E40-925F393A1AC7}" dt="2021-03-26T23:19:11.081" v="1276" actId="20577"/>
        <pc:sldMkLst>
          <pc:docMk/>
          <pc:sldMk cId="1081373503" sldId="257"/>
        </pc:sldMkLst>
        <pc:spChg chg="mod">
          <ac:chgData name="Sarah Hill" userId="b774f213905f0ee8" providerId="LiveId" clId="{7570F448-2C5D-4B03-9E40-925F393A1AC7}" dt="2021-03-25T13:10:19.973" v="1235" actId="20577"/>
          <ac:spMkLst>
            <pc:docMk/>
            <pc:sldMk cId="1081373503" sldId="257"/>
            <ac:spMk id="2" creationId="{1C27C29A-2405-449F-AA5F-D67B4EE9755F}"/>
          </ac:spMkLst>
        </pc:spChg>
        <pc:spChg chg="add mod">
          <ac:chgData name="Sarah Hill" userId="b774f213905f0ee8" providerId="LiveId" clId="{7570F448-2C5D-4B03-9E40-925F393A1AC7}" dt="2021-03-26T23:19:11.081" v="1276" actId="20577"/>
          <ac:spMkLst>
            <pc:docMk/>
            <pc:sldMk cId="1081373503" sldId="257"/>
            <ac:spMk id="3" creationId="{BB4D77DF-2D7F-4BBA-8254-7B0B2F2A9B92}"/>
          </ac:spMkLst>
        </pc:spChg>
      </pc:sldChg>
      <pc:sldChg chg="addSp delSp modSp new mod">
        <pc:chgData name="Sarah Hill" userId="b774f213905f0ee8" providerId="LiveId" clId="{7570F448-2C5D-4B03-9E40-925F393A1AC7}" dt="2021-03-25T13:10:33.782" v="1245" actId="20577"/>
        <pc:sldMkLst>
          <pc:docMk/>
          <pc:sldMk cId="2231503832" sldId="258"/>
        </pc:sldMkLst>
        <pc:spChg chg="add del mod">
          <ac:chgData name="Sarah Hill" userId="b774f213905f0ee8" providerId="LiveId" clId="{7570F448-2C5D-4B03-9E40-925F393A1AC7}" dt="2021-03-25T05:08:53.814" v="329" actId="478"/>
          <ac:spMkLst>
            <pc:docMk/>
            <pc:sldMk cId="2231503832" sldId="258"/>
            <ac:spMk id="2" creationId="{4E6B7A45-0B0B-45B5-8057-11342D7A2881}"/>
          </ac:spMkLst>
        </pc:spChg>
        <pc:spChg chg="add mod">
          <ac:chgData name="Sarah Hill" userId="b774f213905f0ee8" providerId="LiveId" clId="{7570F448-2C5D-4B03-9E40-925F393A1AC7}" dt="2021-03-25T13:10:33.782" v="1245" actId="20577"/>
          <ac:spMkLst>
            <pc:docMk/>
            <pc:sldMk cId="2231503832" sldId="258"/>
            <ac:spMk id="3" creationId="{DDCF84CF-BE9C-4D34-837E-11E1333309BC}"/>
          </ac:spMkLst>
        </pc:spChg>
      </pc:sldChg>
      <pc:sldChg chg="addSp delSp modSp new mod">
        <pc:chgData name="Sarah Hill" userId="b774f213905f0ee8" providerId="LiveId" clId="{7570F448-2C5D-4B03-9E40-925F393A1AC7}" dt="2021-03-27T18:14:49.187" v="1303" actId="20577"/>
        <pc:sldMkLst>
          <pc:docMk/>
          <pc:sldMk cId="423082506" sldId="259"/>
        </pc:sldMkLst>
        <pc:spChg chg="add mod">
          <ac:chgData name="Sarah Hill" userId="b774f213905f0ee8" providerId="LiveId" clId="{7570F448-2C5D-4B03-9E40-925F393A1AC7}" dt="2021-03-25T12:23:39.573" v="1214" actId="1036"/>
          <ac:spMkLst>
            <pc:docMk/>
            <pc:sldMk cId="423082506" sldId="259"/>
            <ac:spMk id="8" creationId="{EF2DBB47-C8FF-4642-896C-FFA21B2FC41F}"/>
          </ac:spMkLst>
        </pc:spChg>
        <pc:spChg chg="add del mod">
          <ac:chgData name="Sarah Hill" userId="b774f213905f0ee8" providerId="LiveId" clId="{7570F448-2C5D-4B03-9E40-925F393A1AC7}" dt="2021-03-25T12:18:57.917" v="979" actId="478"/>
          <ac:spMkLst>
            <pc:docMk/>
            <pc:sldMk cId="423082506" sldId="259"/>
            <ac:spMk id="9" creationId="{992D0DA4-F0F8-46C1-8541-5B0D1306090E}"/>
          </ac:spMkLst>
        </pc:spChg>
        <pc:spChg chg="add mod">
          <ac:chgData name="Sarah Hill" userId="b774f213905f0ee8" providerId="LiveId" clId="{7570F448-2C5D-4B03-9E40-925F393A1AC7}" dt="2021-03-25T12:23:39.573" v="1214" actId="1036"/>
          <ac:spMkLst>
            <pc:docMk/>
            <pc:sldMk cId="423082506" sldId="259"/>
            <ac:spMk id="10" creationId="{50902C2C-F006-4BE8-A628-D87B6DC37BEC}"/>
          </ac:spMkLst>
        </pc:spChg>
        <pc:spChg chg="add mod">
          <ac:chgData name="Sarah Hill" userId="b774f213905f0ee8" providerId="LiveId" clId="{7570F448-2C5D-4B03-9E40-925F393A1AC7}" dt="2021-03-25T12:18:16.510" v="958" actId="1035"/>
          <ac:spMkLst>
            <pc:docMk/>
            <pc:sldMk cId="423082506" sldId="259"/>
            <ac:spMk id="13" creationId="{E4391F27-062E-4976-B650-6EA36F23BC0B}"/>
          </ac:spMkLst>
        </pc:spChg>
        <pc:spChg chg="add del mod">
          <ac:chgData name="Sarah Hill" userId="b774f213905f0ee8" providerId="LiveId" clId="{7570F448-2C5D-4B03-9E40-925F393A1AC7}" dt="2021-03-25T12:18:21.556" v="959" actId="478"/>
          <ac:spMkLst>
            <pc:docMk/>
            <pc:sldMk cId="423082506" sldId="259"/>
            <ac:spMk id="15" creationId="{D88F1435-C849-4590-AA9E-EA627E7D0009}"/>
          </ac:spMkLst>
        </pc:spChg>
        <pc:spChg chg="add mod">
          <ac:chgData name="Sarah Hill" userId="b774f213905f0ee8" providerId="LiveId" clId="{7570F448-2C5D-4B03-9E40-925F393A1AC7}" dt="2021-03-25T12:22:44.041" v="1180" actId="1076"/>
          <ac:spMkLst>
            <pc:docMk/>
            <pc:sldMk cId="423082506" sldId="259"/>
            <ac:spMk id="15" creationId="{F6B56519-A29E-45B1-996F-F0944E16A30A}"/>
          </ac:spMkLst>
        </pc:spChg>
        <pc:spChg chg="add mod">
          <ac:chgData name="Sarah Hill" userId="b774f213905f0ee8" providerId="LiveId" clId="{7570F448-2C5D-4B03-9E40-925F393A1AC7}" dt="2021-03-25T12:22:44.041" v="1180" actId="1076"/>
          <ac:spMkLst>
            <pc:docMk/>
            <pc:sldMk cId="423082506" sldId="259"/>
            <ac:spMk id="16" creationId="{0A2BBDD8-65D3-4B03-A98B-57F8861A5D46}"/>
          </ac:spMkLst>
        </pc:spChg>
        <pc:spChg chg="add del mod">
          <ac:chgData name="Sarah Hill" userId="b774f213905f0ee8" providerId="LiveId" clId="{7570F448-2C5D-4B03-9E40-925F393A1AC7}" dt="2021-03-25T12:17:32.048" v="851" actId="478"/>
          <ac:spMkLst>
            <pc:docMk/>
            <pc:sldMk cId="423082506" sldId="259"/>
            <ac:spMk id="16" creationId="{58759949-7206-439D-B78A-1D84C9DA9E2B}"/>
          </ac:spMkLst>
        </pc:spChg>
        <pc:spChg chg="add del mod">
          <ac:chgData name="Sarah Hill" userId="b774f213905f0ee8" providerId="LiveId" clId="{7570F448-2C5D-4B03-9E40-925F393A1AC7}" dt="2021-03-25T12:18:21.556" v="959" actId="478"/>
          <ac:spMkLst>
            <pc:docMk/>
            <pc:sldMk cId="423082506" sldId="259"/>
            <ac:spMk id="17" creationId="{15B3889F-3C2D-4B99-86FB-A370E17E4FC3}"/>
          </ac:spMkLst>
        </pc:spChg>
        <pc:spChg chg="add mod">
          <ac:chgData name="Sarah Hill" userId="b774f213905f0ee8" providerId="LiveId" clId="{7570F448-2C5D-4B03-9E40-925F393A1AC7}" dt="2021-03-25T12:23:39.573" v="1214" actId="1036"/>
          <ac:spMkLst>
            <pc:docMk/>
            <pc:sldMk cId="423082506" sldId="259"/>
            <ac:spMk id="17" creationId="{B55F81BC-A680-4F01-9126-59C7105336A3}"/>
          </ac:spMkLst>
        </pc:spChg>
        <pc:spChg chg="add mod">
          <ac:chgData name="Sarah Hill" userId="b774f213905f0ee8" providerId="LiveId" clId="{7570F448-2C5D-4B03-9E40-925F393A1AC7}" dt="2021-03-25T05:18:41.552" v="537" actId="14100"/>
          <ac:spMkLst>
            <pc:docMk/>
            <pc:sldMk cId="423082506" sldId="259"/>
            <ac:spMk id="18" creationId="{665A5F85-C849-441C-9D09-504A6162A446}"/>
          </ac:spMkLst>
        </pc:spChg>
        <pc:spChg chg="add del mod">
          <ac:chgData name="Sarah Hill" userId="b774f213905f0ee8" providerId="LiveId" clId="{7570F448-2C5D-4B03-9E40-925F393A1AC7}" dt="2021-03-25T12:22:30.972" v="1178" actId="478"/>
          <ac:spMkLst>
            <pc:docMk/>
            <pc:sldMk cId="423082506" sldId="259"/>
            <ac:spMk id="19" creationId="{311FEF7D-7831-4360-B9DA-CB0F5DD69D89}"/>
          </ac:spMkLst>
        </pc:spChg>
        <pc:spChg chg="add mod">
          <ac:chgData name="Sarah Hill" userId="b774f213905f0ee8" providerId="LiveId" clId="{7570F448-2C5D-4B03-9E40-925F393A1AC7}" dt="2021-03-25T12:18:06.246" v="947" actId="1036"/>
          <ac:spMkLst>
            <pc:docMk/>
            <pc:sldMk cId="423082506" sldId="259"/>
            <ac:spMk id="20" creationId="{666946FA-9F6C-4B7C-836C-1F91D4C684CD}"/>
          </ac:spMkLst>
        </pc:spChg>
        <pc:spChg chg="add mod">
          <ac:chgData name="Sarah Hill" userId="b774f213905f0ee8" providerId="LiveId" clId="{7570F448-2C5D-4B03-9E40-925F393A1AC7}" dt="2021-03-27T18:14:49.187" v="1303" actId="20577"/>
          <ac:spMkLst>
            <pc:docMk/>
            <pc:sldMk cId="423082506" sldId="259"/>
            <ac:spMk id="21" creationId="{5DBFECA8-BCE0-49B1-9243-3A285DA4509C}"/>
          </ac:spMkLst>
        </pc:spChg>
        <pc:spChg chg="add mod">
          <ac:chgData name="Sarah Hill" userId="b774f213905f0ee8" providerId="LiveId" clId="{7570F448-2C5D-4B03-9E40-925F393A1AC7}" dt="2021-03-25T12:18:40.081" v="975" actId="14100"/>
          <ac:spMkLst>
            <pc:docMk/>
            <pc:sldMk cId="423082506" sldId="259"/>
            <ac:spMk id="22" creationId="{2E0840A3-4353-4AAB-8C76-06DBEE158E17}"/>
          </ac:spMkLst>
        </pc:spChg>
        <pc:spChg chg="add del mod">
          <ac:chgData name="Sarah Hill" userId="b774f213905f0ee8" providerId="LiveId" clId="{7570F448-2C5D-4B03-9E40-925F393A1AC7}" dt="2021-03-25T12:18:42.875" v="976" actId="478"/>
          <ac:spMkLst>
            <pc:docMk/>
            <pc:sldMk cId="423082506" sldId="259"/>
            <ac:spMk id="23" creationId="{85BD9CD3-8EC3-4A51-8725-BA941C1CE488}"/>
          </ac:spMkLst>
        </pc:spChg>
        <pc:spChg chg="add mod">
          <ac:chgData name="Sarah Hill" userId="b774f213905f0ee8" providerId="LiveId" clId="{7570F448-2C5D-4B03-9E40-925F393A1AC7}" dt="2021-03-25T12:23:39.573" v="1214" actId="1036"/>
          <ac:spMkLst>
            <pc:docMk/>
            <pc:sldMk cId="423082506" sldId="259"/>
            <ac:spMk id="23" creationId="{CE5A21EF-8D0C-430B-A0C9-30064E9513B7}"/>
          </ac:spMkLst>
        </pc:spChg>
        <pc:spChg chg="add mod">
          <ac:chgData name="Sarah Hill" userId="b774f213905f0ee8" providerId="LiveId" clId="{7570F448-2C5D-4B03-9E40-925F393A1AC7}" dt="2021-03-25T12:18:31.701" v="974" actId="1038"/>
          <ac:spMkLst>
            <pc:docMk/>
            <pc:sldMk cId="423082506" sldId="259"/>
            <ac:spMk id="24" creationId="{9C038547-E2D0-4062-B7D5-FC02AECEAB67}"/>
          </ac:spMkLst>
        </pc:spChg>
        <pc:spChg chg="add mod">
          <ac:chgData name="Sarah Hill" userId="b774f213905f0ee8" providerId="LiveId" clId="{7570F448-2C5D-4B03-9E40-925F393A1AC7}" dt="2021-03-25T12:23:39.573" v="1214" actId="1036"/>
          <ac:spMkLst>
            <pc:docMk/>
            <pc:sldMk cId="423082506" sldId="259"/>
            <ac:spMk id="25" creationId="{AEB2F193-90E9-4168-BFD5-27626830CD0F}"/>
          </ac:spMkLst>
        </pc:spChg>
        <pc:picChg chg="add del mod">
          <ac:chgData name="Sarah Hill" userId="b774f213905f0ee8" providerId="LiveId" clId="{7570F448-2C5D-4B03-9E40-925F393A1AC7}" dt="2021-03-25T05:10:43.830" v="432" actId="478"/>
          <ac:picMkLst>
            <pc:docMk/>
            <pc:sldMk cId="423082506" sldId="259"/>
            <ac:picMk id="3" creationId="{C790369D-08EA-447C-B4F9-32E18B8515E4}"/>
          </ac:picMkLst>
        </pc:picChg>
        <pc:picChg chg="add del mod">
          <ac:chgData name="Sarah Hill" userId="b774f213905f0ee8" providerId="LiveId" clId="{7570F448-2C5D-4B03-9E40-925F393A1AC7}" dt="2021-03-25T05:11:39.630" v="439" actId="478"/>
          <ac:picMkLst>
            <pc:docMk/>
            <pc:sldMk cId="423082506" sldId="259"/>
            <ac:picMk id="5" creationId="{793A849A-505D-42F9-8908-5B8710C56DAD}"/>
          </ac:picMkLst>
        </pc:picChg>
        <pc:picChg chg="add mod modCrop">
          <ac:chgData name="Sarah Hill" userId="b774f213905f0ee8" providerId="LiveId" clId="{7570F448-2C5D-4B03-9E40-925F393A1AC7}" dt="2021-03-25T12:23:39.573" v="1214" actId="1036"/>
          <ac:picMkLst>
            <pc:docMk/>
            <pc:sldMk cId="423082506" sldId="259"/>
            <ac:picMk id="7" creationId="{C298CF2F-AF97-4E68-974A-67B1877E2477}"/>
          </ac:picMkLst>
        </pc:picChg>
        <pc:picChg chg="add mod modCrop">
          <ac:chgData name="Sarah Hill" userId="b774f213905f0ee8" providerId="LiveId" clId="{7570F448-2C5D-4B03-9E40-925F393A1AC7}" dt="2021-03-25T05:17:51.468" v="474" actId="1076"/>
          <ac:picMkLst>
            <pc:docMk/>
            <pc:sldMk cId="423082506" sldId="259"/>
            <ac:picMk id="12" creationId="{8AA83671-A865-4EDE-8ADD-2FA79080E255}"/>
          </ac:picMkLst>
        </pc:picChg>
        <pc:picChg chg="add mod modCrop">
          <ac:chgData name="Sarah Hill" userId="b774f213905f0ee8" providerId="LiveId" clId="{7570F448-2C5D-4B03-9E40-925F393A1AC7}" dt="2021-03-25T12:22:48.044" v="1183" actId="1076"/>
          <ac:picMkLst>
            <pc:docMk/>
            <pc:sldMk cId="423082506" sldId="259"/>
            <ac:picMk id="14" creationId="{7FF8800B-E865-4265-8CBB-FE8B45E6525D}"/>
          </ac:picMkLst>
        </pc:picChg>
      </pc:sldChg>
      <pc:sldChg chg="addSp delSp modSp new mod">
        <pc:chgData name="Sarah Hill" userId="b774f213905f0ee8" providerId="LiveId" clId="{7570F448-2C5D-4B03-9E40-925F393A1AC7}" dt="2021-03-25T12:22:23.225" v="1176" actId="1035"/>
        <pc:sldMkLst>
          <pc:docMk/>
          <pc:sldMk cId="1443958332" sldId="260"/>
        </pc:sldMkLst>
        <pc:spChg chg="add del mod">
          <ac:chgData name="Sarah Hill" userId="b774f213905f0ee8" providerId="LiveId" clId="{7570F448-2C5D-4B03-9E40-925F393A1AC7}" dt="2021-03-25T12:16:48.534" v="725" actId="478"/>
          <ac:spMkLst>
            <pc:docMk/>
            <pc:sldMk cId="1443958332" sldId="260"/>
            <ac:spMk id="4" creationId="{7DB47856-1061-414B-A007-863B88E5BE1A}"/>
          </ac:spMkLst>
        </pc:spChg>
        <pc:spChg chg="add del mod">
          <ac:chgData name="Sarah Hill" userId="b774f213905f0ee8" providerId="LiveId" clId="{7570F448-2C5D-4B03-9E40-925F393A1AC7}" dt="2021-03-25T12:16:48.534" v="725" actId="478"/>
          <ac:spMkLst>
            <pc:docMk/>
            <pc:sldMk cId="1443958332" sldId="260"/>
            <ac:spMk id="5" creationId="{E9EA127A-6FC2-407F-8B54-39AAC772F4E9}"/>
          </ac:spMkLst>
        </pc:spChg>
        <pc:spChg chg="add del mod">
          <ac:chgData name="Sarah Hill" userId="b774f213905f0ee8" providerId="LiveId" clId="{7570F448-2C5D-4B03-9E40-925F393A1AC7}" dt="2021-03-25T12:17:09.048" v="778" actId="478"/>
          <ac:spMkLst>
            <pc:docMk/>
            <pc:sldMk cId="1443958332" sldId="260"/>
            <ac:spMk id="6" creationId="{B4A5F918-57E7-44AB-84FD-33E8ED9CB178}"/>
          </ac:spMkLst>
        </pc:spChg>
        <pc:spChg chg="add del mod">
          <ac:chgData name="Sarah Hill" userId="b774f213905f0ee8" providerId="LiveId" clId="{7570F448-2C5D-4B03-9E40-925F393A1AC7}" dt="2021-03-25T12:17:09.048" v="778" actId="478"/>
          <ac:spMkLst>
            <pc:docMk/>
            <pc:sldMk cId="1443958332" sldId="260"/>
            <ac:spMk id="7" creationId="{9D03291E-22C0-4A9C-BC2D-C44024C1EABD}"/>
          </ac:spMkLst>
        </pc:spChg>
        <pc:spChg chg="add mod">
          <ac:chgData name="Sarah Hill" userId="b774f213905f0ee8" providerId="LiveId" clId="{7570F448-2C5D-4B03-9E40-925F393A1AC7}" dt="2021-03-25T05:22:58.337" v="645" actId="14100"/>
          <ac:spMkLst>
            <pc:docMk/>
            <pc:sldMk cId="1443958332" sldId="260"/>
            <ac:spMk id="8" creationId="{75936AD4-5BB6-4400-8D1D-CCAE94BA5DC4}"/>
          </ac:spMkLst>
        </pc:spChg>
        <pc:spChg chg="add mod">
          <ac:chgData name="Sarah Hill" userId="b774f213905f0ee8" providerId="LiveId" clId="{7570F448-2C5D-4B03-9E40-925F393A1AC7}" dt="2021-03-25T05:23:07.470" v="651" actId="20577"/>
          <ac:spMkLst>
            <pc:docMk/>
            <pc:sldMk cId="1443958332" sldId="260"/>
            <ac:spMk id="9" creationId="{83C91376-15CC-45C3-B3AC-97ABB78D8E86}"/>
          </ac:spMkLst>
        </pc:spChg>
        <pc:spChg chg="add mod">
          <ac:chgData name="Sarah Hill" userId="b774f213905f0ee8" providerId="LiveId" clId="{7570F448-2C5D-4B03-9E40-925F393A1AC7}" dt="2021-03-25T05:23:23.914" v="705" actId="20577"/>
          <ac:spMkLst>
            <pc:docMk/>
            <pc:sldMk cId="1443958332" sldId="260"/>
            <ac:spMk id="10" creationId="{CF9048D5-3639-4725-B32A-19A4566679A6}"/>
          </ac:spMkLst>
        </pc:spChg>
        <pc:spChg chg="add del mod">
          <ac:chgData name="Sarah Hill" userId="b774f213905f0ee8" providerId="LiveId" clId="{7570F448-2C5D-4B03-9E40-925F393A1AC7}" dt="2021-03-25T12:17:12.836" v="779" actId="478"/>
          <ac:spMkLst>
            <pc:docMk/>
            <pc:sldMk cId="1443958332" sldId="260"/>
            <ac:spMk id="11" creationId="{757AD7D1-3586-4B51-BBB1-1EFF3F9A06A0}"/>
          </ac:spMkLst>
        </pc:spChg>
        <pc:spChg chg="add mod">
          <ac:chgData name="Sarah Hill" userId="b774f213905f0ee8" providerId="LiveId" clId="{7570F448-2C5D-4B03-9E40-925F393A1AC7}" dt="2021-03-25T12:16:54.985" v="727" actId="1076"/>
          <ac:spMkLst>
            <pc:docMk/>
            <pc:sldMk cId="1443958332" sldId="260"/>
            <ac:spMk id="12" creationId="{4FED34BC-9423-4486-8519-A6E8119F4D6B}"/>
          </ac:spMkLst>
        </pc:spChg>
        <pc:spChg chg="add del mod">
          <ac:chgData name="Sarah Hill" userId="b774f213905f0ee8" providerId="LiveId" clId="{7570F448-2C5D-4B03-9E40-925F393A1AC7}" dt="2021-03-25T12:22:04.405" v="1052" actId="478"/>
          <ac:spMkLst>
            <pc:docMk/>
            <pc:sldMk cId="1443958332" sldId="260"/>
            <ac:spMk id="13" creationId="{870CD7F8-D01E-4699-98BB-0865CCD8A609}"/>
          </ac:spMkLst>
        </pc:spChg>
        <pc:spChg chg="add mod">
          <ac:chgData name="Sarah Hill" userId="b774f213905f0ee8" providerId="LiveId" clId="{7570F448-2C5D-4B03-9E40-925F393A1AC7}" dt="2021-03-25T12:22:09.120" v="1080" actId="1035"/>
          <ac:spMkLst>
            <pc:docMk/>
            <pc:sldMk cId="1443958332" sldId="260"/>
            <ac:spMk id="14" creationId="{AC748188-9F55-4374-9D1A-B14F3683F00B}"/>
          </ac:spMkLst>
        </pc:spChg>
        <pc:spChg chg="add mod">
          <ac:chgData name="Sarah Hill" userId="b774f213905f0ee8" providerId="LiveId" clId="{7570F448-2C5D-4B03-9E40-925F393A1AC7}" dt="2021-03-25T12:22:13.111" v="1110" actId="1035"/>
          <ac:spMkLst>
            <pc:docMk/>
            <pc:sldMk cId="1443958332" sldId="260"/>
            <ac:spMk id="15" creationId="{4646B1AF-3181-4F6D-9A77-249803252FA1}"/>
          </ac:spMkLst>
        </pc:spChg>
        <pc:spChg chg="add mod">
          <ac:chgData name="Sarah Hill" userId="b774f213905f0ee8" providerId="LiveId" clId="{7570F448-2C5D-4B03-9E40-925F393A1AC7}" dt="2021-03-25T12:17:04.894" v="777" actId="1038"/>
          <ac:spMkLst>
            <pc:docMk/>
            <pc:sldMk cId="1443958332" sldId="260"/>
            <ac:spMk id="16" creationId="{9990B911-3390-48FC-BC01-4A3B4B90B71F}"/>
          </ac:spMkLst>
        </pc:spChg>
        <pc:spChg chg="add mod">
          <ac:chgData name="Sarah Hill" userId="b774f213905f0ee8" providerId="LiveId" clId="{7570F448-2C5D-4B03-9E40-925F393A1AC7}" dt="2021-03-25T12:17:22.178" v="849" actId="1035"/>
          <ac:spMkLst>
            <pc:docMk/>
            <pc:sldMk cId="1443958332" sldId="260"/>
            <ac:spMk id="17" creationId="{26CA99A9-1FD1-477C-A23D-223BF2AB3762}"/>
          </ac:spMkLst>
        </pc:spChg>
        <pc:spChg chg="add del mod">
          <ac:chgData name="Sarah Hill" userId="b774f213905f0ee8" providerId="LiveId" clId="{7570F448-2C5D-4B03-9E40-925F393A1AC7}" dt="2021-03-25T12:22:05.555" v="1053" actId="478"/>
          <ac:spMkLst>
            <pc:docMk/>
            <pc:sldMk cId="1443958332" sldId="260"/>
            <ac:spMk id="18" creationId="{92FE5C20-3F78-4B4A-B992-76714DC5E339}"/>
          </ac:spMkLst>
        </pc:spChg>
        <pc:spChg chg="add mod">
          <ac:chgData name="Sarah Hill" userId="b774f213905f0ee8" providerId="LiveId" clId="{7570F448-2C5D-4B03-9E40-925F393A1AC7}" dt="2021-03-25T12:17:22.178" v="849" actId="1035"/>
          <ac:spMkLst>
            <pc:docMk/>
            <pc:sldMk cId="1443958332" sldId="260"/>
            <ac:spMk id="19" creationId="{908F7B5D-30E8-4F16-B382-3281187CE870}"/>
          </ac:spMkLst>
        </pc:spChg>
        <pc:spChg chg="add mod">
          <ac:chgData name="Sarah Hill" userId="b774f213905f0ee8" providerId="LiveId" clId="{7570F448-2C5D-4B03-9E40-925F393A1AC7}" dt="2021-03-25T12:22:23.225" v="1176" actId="1035"/>
          <ac:spMkLst>
            <pc:docMk/>
            <pc:sldMk cId="1443958332" sldId="260"/>
            <ac:spMk id="20" creationId="{E354BEC5-3971-475B-A879-9BA5B4C2AF93}"/>
          </ac:spMkLst>
        </pc:spChg>
        <pc:spChg chg="add mod">
          <ac:chgData name="Sarah Hill" userId="b774f213905f0ee8" providerId="LiveId" clId="{7570F448-2C5D-4B03-9E40-925F393A1AC7}" dt="2021-03-25T12:22:23.225" v="1176" actId="1035"/>
          <ac:spMkLst>
            <pc:docMk/>
            <pc:sldMk cId="1443958332" sldId="260"/>
            <ac:spMk id="21" creationId="{AEBBC445-6810-4D51-A76B-0763D0DF5A3B}"/>
          </ac:spMkLst>
        </pc:spChg>
        <pc:picChg chg="add mod">
          <ac:chgData name="Sarah Hill" userId="b774f213905f0ee8" providerId="LiveId" clId="{7570F448-2C5D-4B03-9E40-925F393A1AC7}" dt="2021-03-25T05:22:12.166" v="605" actId="1076"/>
          <ac:picMkLst>
            <pc:docMk/>
            <pc:sldMk cId="1443958332" sldId="260"/>
            <ac:picMk id="2" creationId="{993EF231-E0AC-4F1F-9E9F-CED9F77587E6}"/>
          </ac:picMkLst>
        </pc:picChg>
        <pc:picChg chg="add mod">
          <ac:chgData name="Sarah Hill" userId="b774f213905f0ee8" providerId="LiveId" clId="{7570F448-2C5D-4B03-9E40-925F393A1AC7}" dt="2021-03-25T12:16:44.798" v="724" actId="1076"/>
          <ac:picMkLst>
            <pc:docMk/>
            <pc:sldMk cId="1443958332" sldId="260"/>
            <ac:picMk id="3" creationId="{F89B3241-64A9-48FB-A5B5-9D27B967304A}"/>
          </ac:picMkLst>
        </pc:picChg>
      </pc:sldChg>
      <pc:sldChg chg="addSp modSp new mod">
        <pc:chgData name="Sarah Hill" userId="b774f213905f0ee8" providerId="LiveId" clId="{7570F448-2C5D-4B03-9E40-925F393A1AC7}" dt="2021-03-25T13:19:04.377" v="1274" actId="20577"/>
        <pc:sldMkLst>
          <pc:docMk/>
          <pc:sldMk cId="767915520" sldId="261"/>
        </pc:sldMkLst>
        <pc:spChg chg="add mod">
          <ac:chgData name="Sarah Hill" userId="b774f213905f0ee8" providerId="LiveId" clId="{7570F448-2C5D-4B03-9E40-925F393A1AC7}" dt="2021-03-25T13:18:38.597" v="1261" actId="14100"/>
          <ac:spMkLst>
            <pc:docMk/>
            <pc:sldMk cId="767915520" sldId="261"/>
            <ac:spMk id="4" creationId="{9725FF30-2C5B-47F9-ABF2-8188036CFD2D}"/>
          </ac:spMkLst>
        </pc:spChg>
        <pc:spChg chg="add mod">
          <ac:chgData name="Sarah Hill" userId="b774f213905f0ee8" providerId="LiveId" clId="{7570F448-2C5D-4B03-9E40-925F393A1AC7}" dt="2021-03-25T13:18:44.599" v="1264" actId="1036"/>
          <ac:spMkLst>
            <pc:docMk/>
            <pc:sldMk cId="767915520" sldId="261"/>
            <ac:spMk id="5" creationId="{CC6BE29E-B46F-4678-BBDF-E65C182151C8}"/>
          </ac:spMkLst>
        </pc:spChg>
        <pc:spChg chg="add mod">
          <ac:chgData name="Sarah Hill" userId="b774f213905f0ee8" providerId="LiveId" clId="{7570F448-2C5D-4B03-9E40-925F393A1AC7}" dt="2021-03-25T13:19:04.377" v="1274" actId="20577"/>
          <ac:spMkLst>
            <pc:docMk/>
            <pc:sldMk cId="767915520" sldId="261"/>
            <ac:spMk id="6" creationId="{7EA2400D-2C41-4908-9056-890B3B7A8896}"/>
          </ac:spMkLst>
        </pc:spChg>
        <pc:picChg chg="add mod">
          <ac:chgData name="Sarah Hill" userId="b774f213905f0ee8" providerId="LiveId" clId="{7570F448-2C5D-4B03-9E40-925F393A1AC7}" dt="2021-03-25T13:18:08.878" v="1255" actId="14100"/>
          <ac:picMkLst>
            <pc:docMk/>
            <pc:sldMk cId="767915520" sldId="261"/>
            <ac:picMk id="3" creationId="{2213E3FD-CE8B-44F7-839C-C846504938A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777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1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055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270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655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949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042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691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65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48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551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F98174-EF06-48CF-9B73-254CD13402B3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CC764-FBA0-4091-B781-7B21CE0F75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8320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C27C29A-2405-449F-AA5F-D67B4EE9755F}"/>
              </a:ext>
            </a:extLst>
          </p:cNvPr>
          <p:cNvSpPr txBox="1"/>
          <p:nvPr/>
        </p:nvSpPr>
        <p:spPr>
          <a:xfrm>
            <a:off x="1031630" y="1946031"/>
            <a:ext cx="4794739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B ARK1 siLKB1 Gel loading order, please see order below and boxed areas on following slide.</a:t>
            </a:r>
          </a:p>
          <a:p>
            <a:endParaRPr lang="en-US" dirty="0"/>
          </a:p>
          <a:p>
            <a:r>
              <a:rPr lang="en-US" dirty="0"/>
              <a:t>14-Not this figure</a:t>
            </a:r>
          </a:p>
          <a:p>
            <a:r>
              <a:rPr lang="en-US" dirty="0"/>
              <a:t>13-Not this figure</a:t>
            </a:r>
          </a:p>
          <a:p>
            <a:r>
              <a:rPr lang="en-US" dirty="0"/>
              <a:t>12-Ladder</a:t>
            </a:r>
          </a:p>
          <a:p>
            <a:r>
              <a:rPr lang="en-US" dirty="0"/>
              <a:t>11 ARK1 siLKB1 6</a:t>
            </a:r>
          </a:p>
          <a:p>
            <a:r>
              <a:rPr lang="en-US" dirty="0"/>
              <a:t>10 ARK1 siLKB1 1</a:t>
            </a:r>
          </a:p>
          <a:p>
            <a:r>
              <a:rPr lang="en-US" dirty="0"/>
              <a:t>9 ARK1 </a:t>
            </a:r>
            <a:r>
              <a:rPr lang="en-US" dirty="0" err="1"/>
              <a:t>siCONTROL</a:t>
            </a:r>
            <a:endParaRPr lang="en-US" dirty="0"/>
          </a:p>
          <a:p>
            <a:r>
              <a:rPr lang="en-US" dirty="0"/>
              <a:t>8 Not this figure</a:t>
            </a:r>
          </a:p>
          <a:p>
            <a:r>
              <a:rPr lang="en-US" dirty="0"/>
              <a:t>7 Not this figure</a:t>
            </a:r>
          </a:p>
          <a:p>
            <a:r>
              <a:rPr lang="en-US" dirty="0"/>
              <a:t>6 Not this figure</a:t>
            </a:r>
          </a:p>
          <a:p>
            <a:r>
              <a:rPr lang="en-US" dirty="0"/>
              <a:t>5 Not this figure</a:t>
            </a:r>
          </a:p>
          <a:p>
            <a:r>
              <a:rPr lang="en-US" dirty="0"/>
              <a:t>4 Not this figure</a:t>
            </a:r>
          </a:p>
          <a:p>
            <a:r>
              <a:rPr lang="en-US" dirty="0"/>
              <a:t>3 Not this figure</a:t>
            </a:r>
          </a:p>
          <a:p>
            <a:r>
              <a:rPr lang="en-US" dirty="0"/>
              <a:t>2 Not this figure</a:t>
            </a:r>
          </a:p>
          <a:p>
            <a:r>
              <a:rPr lang="en-US" dirty="0"/>
              <a:t>1 Not this figur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4D77DF-2D7F-4BBA-8254-7B0B2F2A9B92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1081373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60931D64-0642-4A8F-9391-7766EE9E4C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971"/>
          <a:stretch/>
        </p:blipFill>
        <p:spPr>
          <a:xfrm>
            <a:off x="0" y="1195754"/>
            <a:ext cx="6858000" cy="389646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7EDDC58-2223-400A-B6F4-F0870F726721}"/>
              </a:ext>
            </a:extLst>
          </p:cNvPr>
          <p:cNvSpPr txBox="1"/>
          <p:nvPr/>
        </p:nvSpPr>
        <p:spPr>
          <a:xfrm>
            <a:off x="1846383" y="926690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KB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05EBF49-2D99-464A-8878-597A0BCAC094}"/>
              </a:ext>
            </a:extLst>
          </p:cNvPr>
          <p:cNvSpPr/>
          <p:nvPr/>
        </p:nvSpPr>
        <p:spPr>
          <a:xfrm>
            <a:off x="1205565" y="2133603"/>
            <a:ext cx="2378764" cy="773724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1EB5E5-0300-4AB2-A26D-D35E71656713}"/>
              </a:ext>
            </a:extLst>
          </p:cNvPr>
          <p:cNvSpPr txBox="1"/>
          <p:nvPr/>
        </p:nvSpPr>
        <p:spPr>
          <a:xfrm rot="16200000">
            <a:off x="1003370" y="577336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4E12B86-BCF5-4395-8FE6-E23A1FE910F4}"/>
              </a:ext>
            </a:extLst>
          </p:cNvPr>
          <p:cNvSpPr txBox="1"/>
          <p:nvPr/>
        </p:nvSpPr>
        <p:spPr>
          <a:xfrm rot="16200000">
            <a:off x="2335822" y="459376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366E9FD-5C98-4173-9E36-A49670CC87C6}"/>
              </a:ext>
            </a:extLst>
          </p:cNvPr>
          <p:cNvSpPr txBox="1"/>
          <p:nvPr/>
        </p:nvSpPr>
        <p:spPr>
          <a:xfrm rot="16200000">
            <a:off x="2486823" y="2285591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-10- 11</a:t>
            </a:r>
          </a:p>
        </p:txBody>
      </p:sp>
    </p:spTree>
    <p:extLst>
      <p:ext uri="{BB962C8B-B14F-4D97-AF65-F5344CB8AC3E}">
        <p14:creationId xmlns:p14="http://schemas.microsoft.com/office/powerpoint/2010/main" val="27241421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&#10;&#10;Description automatically generated">
            <a:extLst>
              <a:ext uri="{FF2B5EF4-FFF2-40B4-BE49-F238E27FC236}">
                <a16:creationId xmlns:a16="http://schemas.microsoft.com/office/drawing/2014/main" id="{993EF231-E0AC-4F1F-9E9F-CED9F77587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15048"/>
          <a:stretch/>
        </p:blipFill>
        <p:spPr>
          <a:xfrm>
            <a:off x="0" y="5174302"/>
            <a:ext cx="6644970" cy="3195975"/>
          </a:xfrm>
          <a:prstGeom prst="rect">
            <a:avLst/>
          </a:prstGeom>
        </p:spPr>
      </p:pic>
      <p:pic>
        <p:nvPicPr>
          <p:cNvPr id="3" name="Picture 2" descr="Diagram, schematic&#10;&#10;Description automatically generated">
            <a:extLst>
              <a:ext uri="{FF2B5EF4-FFF2-40B4-BE49-F238E27FC236}">
                <a16:creationId xmlns:a16="http://schemas.microsoft.com/office/drawing/2014/main" id="{F89B3241-64A9-48FB-A5B5-9D27B967304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103" b="14182"/>
          <a:stretch/>
        </p:blipFill>
        <p:spPr>
          <a:xfrm>
            <a:off x="213030" y="957092"/>
            <a:ext cx="6644970" cy="381442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5936AD4-5BB6-4400-8D1D-CCAE94BA5DC4}"/>
              </a:ext>
            </a:extLst>
          </p:cNvPr>
          <p:cNvSpPr txBox="1"/>
          <p:nvPr/>
        </p:nvSpPr>
        <p:spPr>
          <a:xfrm>
            <a:off x="1140069" y="655083"/>
            <a:ext cx="32209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ubulin dark blot with ladd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C91376-15CC-45C3-B3AC-97ABB78D8E86}"/>
              </a:ext>
            </a:extLst>
          </p:cNvPr>
          <p:cNvSpPr txBox="1"/>
          <p:nvPr/>
        </p:nvSpPr>
        <p:spPr>
          <a:xfrm>
            <a:off x="697526" y="4900254"/>
            <a:ext cx="32209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ubulin use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9048D5-3639-4725-B32A-19A4566679A6}"/>
              </a:ext>
            </a:extLst>
          </p:cNvPr>
          <p:cNvSpPr txBox="1"/>
          <p:nvPr/>
        </p:nvSpPr>
        <p:spPr>
          <a:xfrm>
            <a:off x="1818542" y="17852"/>
            <a:ext cx="32209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ot was stripped and </a:t>
            </a:r>
            <a:r>
              <a:rPr lang="en-US" dirty="0" err="1"/>
              <a:t>restained</a:t>
            </a:r>
            <a:r>
              <a:rPr lang="en-US" dirty="0"/>
              <a:t> for Tubuli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FED34BC-9423-4486-8519-A6E8119F4D6B}"/>
              </a:ext>
            </a:extLst>
          </p:cNvPr>
          <p:cNvSpPr/>
          <p:nvPr/>
        </p:nvSpPr>
        <p:spPr>
          <a:xfrm>
            <a:off x="697526" y="2454537"/>
            <a:ext cx="2378764" cy="773724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C748188-9F55-4374-9D1A-B14F3683F00B}"/>
              </a:ext>
            </a:extLst>
          </p:cNvPr>
          <p:cNvSpPr txBox="1"/>
          <p:nvPr/>
        </p:nvSpPr>
        <p:spPr>
          <a:xfrm rot="16200000">
            <a:off x="495331" y="1707164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46B1AF-3181-4F6D-9A77-249803252FA1}"/>
              </a:ext>
            </a:extLst>
          </p:cNvPr>
          <p:cNvSpPr txBox="1"/>
          <p:nvPr/>
        </p:nvSpPr>
        <p:spPr>
          <a:xfrm rot="16200000">
            <a:off x="1827783" y="1706435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990B911-3390-48FC-BC01-4A3B4B90B71F}"/>
              </a:ext>
            </a:extLst>
          </p:cNvPr>
          <p:cNvSpPr txBox="1"/>
          <p:nvPr/>
        </p:nvSpPr>
        <p:spPr>
          <a:xfrm rot="16200000">
            <a:off x="1849831" y="2524464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-10- 11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6CA99A9-1FD1-477C-A23D-223BF2AB3762}"/>
              </a:ext>
            </a:extLst>
          </p:cNvPr>
          <p:cNvSpPr/>
          <p:nvPr/>
        </p:nvSpPr>
        <p:spPr>
          <a:xfrm>
            <a:off x="486513" y="6053525"/>
            <a:ext cx="2378764" cy="773724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08F7B5D-30E8-4F16-B382-3281187CE870}"/>
              </a:ext>
            </a:extLst>
          </p:cNvPr>
          <p:cNvSpPr txBox="1"/>
          <p:nvPr/>
        </p:nvSpPr>
        <p:spPr>
          <a:xfrm rot="16200000">
            <a:off x="1638818" y="6123452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-10- 1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354BEC5-3971-475B-A879-9BA5B4C2AF93}"/>
              </a:ext>
            </a:extLst>
          </p:cNvPr>
          <p:cNvSpPr txBox="1"/>
          <p:nvPr/>
        </p:nvSpPr>
        <p:spPr>
          <a:xfrm rot="16200000">
            <a:off x="495332" y="5270983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EBBC445-6810-4D51-A76B-0763D0DF5A3B}"/>
              </a:ext>
            </a:extLst>
          </p:cNvPr>
          <p:cNvSpPr txBox="1"/>
          <p:nvPr/>
        </p:nvSpPr>
        <p:spPr>
          <a:xfrm rot="16200000">
            <a:off x="1827784" y="5270254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</p:spTree>
    <p:extLst>
      <p:ext uri="{BB962C8B-B14F-4D97-AF65-F5344CB8AC3E}">
        <p14:creationId xmlns:p14="http://schemas.microsoft.com/office/powerpoint/2010/main" val="14439583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2213E3FD-CE8B-44F7-839C-C846504938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600092" cy="908776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9725FF30-2C5B-47F9-ABF2-8188036CFD2D}"/>
              </a:ext>
            </a:extLst>
          </p:cNvPr>
          <p:cNvSpPr/>
          <p:nvPr/>
        </p:nvSpPr>
        <p:spPr>
          <a:xfrm>
            <a:off x="2368062" y="375138"/>
            <a:ext cx="1289538" cy="1160590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C6BE29E-B46F-4678-BBDF-E65C182151C8}"/>
              </a:ext>
            </a:extLst>
          </p:cNvPr>
          <p:cNvSpPr txBox="1"/>
          <p:nvPr/>
        </p:nvSpPr>
        <p:spPr>
          <a:xfrm rot="16200000">
            <a:off x="1992928" y="844046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9-10- 1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EA2400D-2C41-4908-9056-890B3B7A8896}"/>
              </a:ext>
            </a:extLst>
          </p:cNvPr>
          <p:cNvSpPr txBox="1"/>
          <p:nvPr/>
        </p:nvSpPr>
        <p:spPr>
          <a:xfrm>
            <a:off x="117231" y="175846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21 blot</a:t>
            </a:r>
          </a:p>
        </p:txBody>
      </p:sp>
    </p:spTree>
    <p:extLst>
      <p:ext uri="{BB962C8B-B14F-4D97-AF65-F5344CB8AC3E}">
        <p14:creationId xmlns:p14="http://schemas.microsoft.com/office/powerpoint/2010/main" val="7679155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CF84CF-BE9C-4D34-837E-11E1333309BC}"/>
              </a:ext>
            </a:extLst>
          </p:cNvPr>
          <p:cNvSpPr txBox="1"/>
          <p:nvPr/>
        </p:nvSpPr>
        <p:spPr>
          <a:xfrm>
            <a:off x="1031630" y="2016369"/>
            <a:ext cx="4794739" cy="5632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3B HEC1B siLKB1 Gel loading order, please see order below and boxed areas on following slide.</a:t>
            </a:r>
          </a:p>
          <a:p>
            <a:endParaRPr lang="en-US" dirty="0"/>
          </a:p>
          <a:p>
            <a:r>
              <a:rPr lang="en-US" dirty="0"/>
              <a:t>14-HEC1B siLKB1 6</a:t>
            </a:r>
          </a:p>
          <a:p>
            <a:r>
              <a:rPr lang="en-US" dirty="0"/>
              <a:t>13-HEC1B siLKB1 1</a:t>
            </a:r>
          </a:p>
          <a:p>
            <a:r>
              <a:rPr lang="en-US" dirty="0"/>
              <a:t>12-HEC1B </a:t>
            </a:r>
            <a:r>
              <a:rPr lang="en-US" dirty="0" err="1"/>
              <a:t>siCONTROL</a:t>
            </a:r>
            <a:endParaRPr lang="en-US" dirty="0"/>
          </a:p>
          <a:p>
            <a:r>
              <a:rPr lang="en-US" dirty="0"/>
              <a:t>11 Not this figure</a:t>
            </a:r>
          </a:p>
          <a:p>
            <a:r>
              <a:rPr lang="en-US" dirty="0"/>
              <a:t>10 Not this figure</a:t>
            </a:r>
          </a:p>
          <a:p>
            <a:r>
              <a:rPr lang="en-US" dirty="0"/>
              <a:t>9 Not this figure</a:t>
            </a:r>
          </a:p>
          <a:p>
            <a:r>
              <a:rPr lang="en-US" dirty="0"/>
              <a:t>Membrane cut across ladder at this point</a:t>
            </a:r>
          </a:p>
          <a:p>
            <a:endParaRPr lang="en-US" dirty="0"/>
          </a:p>
          <a:p>
            <a:r>
              <a:rPr lang="en-US" dirty="0"/>
              <a:t>8 Ladder</a:t>
            </a:r>
          </a:p>
          <a:p>
            <a:r>
              <a:rPr lang="en-US" dirty="0"/>
              <a:t>7 Not this figure</a:t>
            </a:r>
          </a:p>
          <a:p>
            <a:r>
              <a:rPr lang="en-US" dirty="0"/>
              <a:t>6 Not this figure</a:t>
            </a:r>
          </a:p>
          <a:p>
            <a:r>
              <a:rPr lang="en-US" dirty="0"/>
              <a:t>5 Not this figure</a:t>
            </a:r>
          </a:p>
          <a:p>
            <a:r>
              <a:rPr lang="en-US" dirty="0"/>
              <a:t>4 Not this figure</a:t>
            </a:r>
          </a:p>
          <a:p>
            <a:r>
              <a:rPr lang="en-US" dirty="0"/>
              <a:t>3 Not this figure</a:t>
            </a:r>
          </a:p>
          <a:p>
            <a:r>
              <a:rPr lang="en-US" dirty="0"/>
              <a:t>2 Not this figure</a:t>
            </a:r>
          </a:p>
          <a:p>
            <a:r>
              <a:rPr lang="en-US" dirty="0"/>
              <a:t>1 Not this figure</a:t>
            </a:r>
          </a:p>
        </p:txBody>
      </p:sp>
    </p:spTree>
    <p:extLst>
      <p:ext uri="{BB962C8B-B14F-4D97-AF65-F5344CB8AC3E}">
        <p14:creationId xmlns:p14="http://schemas.microsoft.com/office/powerpoint/2010/main" val="22315038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gram, engineering drawing&#10;&#10;Description automatically generated">
            <a:extLst>
              <a:ext uri="{FF2B5EF4-FFF2-40B4-BE49-F238E27FC236}">
                <a16:creationId xmlns:a16="http://schemas.microsoft.com/office/drawing/2014/main" id="{C298CF2F-AF97-4E68-974A-67B1877E247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564"/>
          <a:stretch/>
        </p:blipFill>
        <p:spPr>
          <a:xfrm>
            <a:off x="564852" y="5873262"/>
            <a:ext cx="5493836" cy="325315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EF2DBB47-C8FF-4642-896C-FFA21B2FC41F}"/>
              </a:ext>
            </a:extLst>
          </p:cNvPr>
          <p:cNvSpPr/>
          <p:nvPr/>
        </p:nvSpPr>
        <p:spPr>
          <a:xfrm>
            <a:off x="4220307" y="6248401"/>
            <a:ext cx="1184031" cy="5861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0902C2C-F006-4BE8-A628-D87B6DC37BEC}"/>
              </a:ext>
            </a:extLst>
          </p:cNvPr>
          <p:cNvSpPr txBox="1"/>
          <p:nvPr/>
        </p:nvSpPr>
        <p:spPr>
          <a:xfrm>
            <a:off x="4676435" y="5937373"/>
            <a:ext cx="1055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KB1</a:t>
            </a:r>
          </a:p>
        </p:txBody>
      </p:sp>
      <p:pic>
        <p:nvPicPr>
          <p:cNvPr id="12" name="Picture 11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8AA83671-A865-4EDE-8ADD-2FA79080E25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675"/>
          <a:stretch/>
        </p:blipFill>
        <p:spPr>
          <a:xfrm rot="10800000">
            <a:off x="586037" y="2877647"/>
            <a:ext cx="5451465" cy="3176956"/>
          </a:xfrm>
          <a:prstGeom prst="rect">
            <a:avLst/>
          </a:prstGeom>
        </p:spPr>
      </p:pic>
      <p:pic>
        <p:nvPicPr>
          <p:cNvPr id="14" name="Picture 13" descr="Diagram&#10;&#10;Description automatically generated">
            <a:extLst>
              <a:ext uri="{FF2B5EF4-FFF2-40B4-BE49-F238E27FC236}">
                <a16:creationId xmlns:a16="http://schemas.microsoft.com/office/drawing/2014/main" id="{7FF8800B-E865-4265-8CBB-FE8B45E6525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214"/>
          <a:stretch/>
        </p:blipFill>
        <p:spPr>
          <a:xfrm>
            <a:off x="703267" y="0"/>
            <a:ext cx="5451466" cy="307144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65A5F85-C849-441C-9D09-504A6162A446}"/>
              </a:ext>
            </a:extLst>
          </p:cNvPr>
          <p:cNvSpPr txBox="1"/>
          <p:nvPr/>
        </p:nvSpPr>
        <p:spPr>
          <a:xfrm>
            <a:off x="3429000" y="0"/>
            <a:ext cx="2444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ubulin dark exposure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4391F27-062E-4976-B650-6EA36F23BC0B}"/>
              </a:ext>
            </a:extLst>
          </p:cNvPr>
          <p:cNvSpPr/>
          <p:nvPr/>
        </p:nvSpPr>
        <p:spPr>
          <a:xfrm>
            <a:off x="3537209" y="322128"/>
            <a:ext cx="2378764" cy="596898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66946FA-9F6C-4B7C-836C-1F91D4C684CD}"/>
              </a:ext>
            </a:extLst>
          </p:cNvPr>
          <p:cNvSpPr txBox="1"/>
          <p:nvPr/>
        </p:nvSpPr>
        <p:spPr>
          <a:xfrm rot="16200000">
            <a:off x="4616478" y="355694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-13- 1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BFECA8-BCE0-49B1-9243-3A285DA4509C}"/>
              </a:ext>
            </a:extLst>
          </p:cNvPr>
          <p:cNvSpPr txBox="1"/>
          <p:nvPr/>
        </p:nvSpPr>
        <p:spPr>
          <a:xfrm>
            <a:off x="82061" y="2924255"/>
            <a:ext cx="2444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ubulin used in figure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E0840A3-4353-4AAB-8C76-06DBEE158E17}"/>
              </a:ext>
            </a:extLst>
          </p:cNvPr>
          <p:cNvSpPr/>
          <p:nvPr/>
        </p:nvSpPr>
        <p:spPr>
          <a:xfrm>
            <a:off x="703266" y="3246383"/>
            <a:ext cx="1865767" cy="596898"/>
          </a:xfrm>
          <a:prstGeom prst="rect">
            <a:avLst/>
          </a:prstGeom>
          <a:noFill/>
          <a:ln w="476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C038547-E2D0-4062-B7D5-FC02AECEAB67}"/>
              </a:ext>
            </a:extLst>
          </p:cNvPr>
          <p:cNvSpPr txBox="1"/>
          <p:nvPr/>
        </p:nvSpPr>
        <p:spPr>
          <a:xfrm rot="16200000">
            <a:off x="1269539" y="3279949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-13- 1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EB2F193-90E9-4168-BFD5-27626830CD0F}"/>
              </a:ext>
            </a:extLst>
          </p:cNvPr>
          <p:cNvSpPr txBox="1"/>
          <p:nvPr/>
        </p:nvSpPr>
        <p:spPr>
          <a:xfrm rot="16200000">
            <a:off x="4978803" y="6248398"/>
            <a:ext cx="996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-13- 1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6B56519-A29E-45B1-996F-F0944E16A30A}"/>
              </a:ext>
            </a:extLst>
          </p:cNvPr>
          <p:cNvSpPr txBox="1"/>
          <p:nvPr/>
        </p:nvSpPr>
        <p:spPr>
          <a:xfrm rot="16200000">
            <a:off x="533718" y="3932103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A2BBDD8-65D3-4B03-A98B-57F8861A5D46}"/>
              </a:ext>
            </a:extLst>
          </p:cNvPr>
          <p:cNvSpPr txBox="1"/>
          <p:nvPr/>
        </p:nvSpPr>
        <p:spPr>
          <a:xfrm rot="16200000">
            <a:off x="1866170" y="3931374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55F81BC-A680-4F01-9126-59C7105336A3}"/>
              </a:ext>
            </a:extLst>
          </p:cNvPr>
          <p:cNvSpPr txBox="1"/>
          <p:nvPr/>
        </p:nvSpPr>
        <p:spPr>
          <a:xfrm rot="16200000">
            <a:off x="3828486" y="8504098"/>
            <a:ext cx="773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E5A21EF-8D0C-430B-A0C9-30064E9513B7}"/>
              </a:ext>
            </a:extLst>
          </p:cNvPr>
          <p:cNvSpPr txBox="1"/>
          <p:nvPr/>
        </p:nvSpPr>
        <p:spPr>
          <a:xfrm rot="16200000">
            <a:off x="5160938" y="8409585"/>
            <a:ext cx="1148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ottom</a:t>
            </a:r>
          </a:p>
        </p:txBody>
      </p:sp>
    </p:spTree>
    <p:extLst>
      <p:ext uri="{BB962C8B-B14F-4D97-AF65-F5344CB8AC3E}">
        <p14:creationId xmlns:p14="http://schemas.microsoft.com/office/powerpoint/2010/main" val="423082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2</Words>
  <Application>Microsoft Office PowerPoint</Application>
  <PresentationFormat>Letter Paper (8.5x11 in)</PresentationFormat>
  <Paragraphs>6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Hill</dc:creator>
  <cp:lastModifiedBy>Sarah Hill</cp:lastModifiedBy>
  <cp:revision>2</cp:revision>
  <dcterms:created xsi:type="dcterms:W3CDTF">2021-03-25T04:32:01Z</dcterms:created>
  <dcterms:modified xsi:type="dcterms:W3CDTF">2021-03-27T18:15:04Z</dcterms:modified>
</cp:coreProperties>
</file>